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7" r:id="rId2"/>
    <p:sldId id="271" r:id="rId3"/>
    <p:sldId id="272" r:id="rId4"/>
    <p:sldId id="273" r:id="rId5"/>
    <p:sldId id="274" r:id="rId6"/>
    <p:sldId id="275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2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61"/>
    <p:restoredTop sz="94590"/>
  </p:normalViewPr>
  <p:slideViewPr>
    <p:cSldViewPr snapToGrid="0" snapToObjects="1">
      <p:cViewPr>
        <p:scale>
          <a:sx n="110" d="100"/>
          <a:sy n="110" d="100"/>
        </p:scale>
        <p:origin x="2016" y="-1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734082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3637379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663613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042154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485393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753415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210358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854165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22212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56074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21529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ADF879-48A0-0446-BCD6-D13A92430B33}" type="datetimeFigureOut">
              <a:rPr lang="en-SA" smtClean="0"/>
              <a:t>13/10/2020 R</a:t>
            </a:fld>
            <a:endParaRPr lang="en-S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D4F2E-1AF7-5D4C-BEB7-51A26F30B819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4188374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1EF645C-B9EC-C247-92AC-9A4EFF668F29}"/>
              </a:ext>
            </a:extLst>
          </p:cNvPr>
          <p:cNvSpPr/>
          <p:nvPr/>
        </p:nvSpPr>
        <p:spPr>
          <a:xfrm>
            <a:off x="160718" y="8411647"/>
            <a:ext cx="655440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diction of RNA secondary structures for genomic regions spanning identified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s-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ng RNA elements in SARS-CoV-2.</a:t>
            </a:r>
          </a:p>
        </p:txBody>
      </p:sp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5E2CE607-CABD-2641-85A5-B196C6B0FF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574676"/>
            <a:ext cx="6858000" cy="2756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9634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5BC80A7C-BF32-6F4E-BAEE-720F810179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7163481"/>
              </p:ext>
            </p:extLst>
          </p:nvPr>
        </p:nvGraphicFramePr>
        <p:xfrm>
          <a:off x="1181277" y="519764"/>
          <a:ext cx="4564884" cy="39855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82442">
                  <a:extLst>
                    <a:ext uri="{9D8B030D-6E8A-4147-A177-3AD203B41FA5}">
                      <a16:colId xmlns:a16="http://schemas.microsoft.com/office/drawing/2014/main" val="3582623480"/>
                    </a:ext>
                  </a:extLst>
                </a:gridCol>
                <a:gridCol w="2282442">
                  <a:extLst>
                    <a:ext uri="{9D8B030D-6E8A-4147-A177-3AD203B41FA5}">
                      <a16:colId xmlns:a16="http://schemas.microsoft.com/office/drawing/2014/main" val="3653733296"/>
                    </a:ext>
                  </a:extLst>
                </a:gridCol>
              </a:tblGrid>
              <a:tr h="31470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earch-Rf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803966"/>
                  </a:ext>
                </a:extLst>
              </a:tr>
              <a:tr h="1347813">
                <a:tc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327281"/>
                  </a:ext>
                </a:extLst>
              </a:tr>
              <a:tr h="720383">
                <a:tc gridSpan="2"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272734"/>
                  </a:ext>
                </a:extLst>
              </a:tr>
              <a:tr h="306621">
                <a:tc gridSpan="2">
                  <a:txBody>
                    <a:bodyPr/>
                    <a:lstStyle/>
                    <a:p>
                      <a:pPr algn="ctr"/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fold 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condary annotations and modelled 3D structure</a:t>
                      </a:r>
                      <a:endParaRPr lang="en-SA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115759"/>
                  </a:ext>
                </a:extLst>
              </a:tr>
              <a:tr h="1296000">
                <a:tc>
                  <a:txBody>
                    <a:bodyPr/>
                    <a:lstStyle/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sequnce: 40</a:t>
                      </a: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match: 3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48173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66B40C8E-DBA1-064A-A3D1-64E35E347D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87" t="34120" r="18861" b="62914"/>
          <a:stretch/>
        </p:blipFill>
        <p:spPr bwMode="auto">
          <a:xfrm>
            <a:off x="3504087" y="1742526"/>
            <a:ext cx="689675" cy="396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CF7F6E-CFAF-6F47-B070-8BC8D3313689}"/>
              </a:ext>
            </a:extLst>
          </p:cNvPr>
          <p:cNvSpPr txBox="1"/>
          <p:nvPr/>
        </p:nvSpPr>
        <p:spPr>
          <a:xfrm>
            <a:off x="1228459" y="898332"/>
            <a:ext cx="140455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Famil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fiv_FSE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Taxonom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Viruses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Ontolog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Not foun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CBBB20-0D38-8942-B3AC-6FD7671A3D09}"/>
              </a:ext>
            </a:extLst>
          </p:cNvPr>
          <p:cNvSpPr txBox="1"/>
          <p:nvPr/>
        </p:nvSpPr>
        <p:spPr>
          <a:xfrm>
            <a:off x="317500" y="29210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323EC85-4FA7-5240-9285-D35C1DD30864}"/>
              </a:ext>
            </a:extLst>
          </p:cNvPr>
          <p:cNvSpPr/>
          <p:nvPr/>
        </p:nvSpPr>
        <p:spPr>
          <a:xfrm>
            <a:off x="327118" y="479911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5D43CE1-260F-CA4F-BD89-C8EA08AF19A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45" t="34576" r="47271" b="55387"/>
          <a:stretch/>
        </p:blipFill>
        <p:spPr bwMode="auto">
          <a:xfrm>
            <a:off x="2066108" y="2216649"/>
            <a:ext cx="2725783" cy="6654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411904A-41B6-D74D-AAD1-1BBCCCEC94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03" t="19181" r="38540" b="70451"/>
          <a:stretch/>
        </p:blipFill>
        <p:spPr bwMode="auto">
          <a:xfrm>
            <a:off x="4189267" y="853323"/>
            <a:ext cx="1476000" cy="108720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D68F0FE-FC8D-0F4D-8EFF-36D3381705A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42" t="50552" r="52241" b="41354"/>
          <a:stretch/>
        </p:blipFill>
        <p:spPr bwMode="auto">
          <a:xfrm>
            <a:off x="1228459" y="3284133"/>
            <a:ext cx="2016000" cy="47083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1" name="Picture 20" descr="A close up of a logo&#10;&#10;Description automatically generated">
            <a:extLst>
              <a:ext uri="{FF2B5EF4-FFF2-40B4-BE49-F238E27FC236}">
                <a16:creationId xmlns:a16="http://schemas.microsoft.com/office/drawing/2014/main" id="{82AADA1C-307A-7E4B-838D-57D964DB47D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056" t="14112" r="18985" b="6343"/>
          <a:stretch/>
        </p:blipFill>
        <p:spPr>
          <a:xfrm flipV="1">
            <a:off x="4412812" y="3248612"/>
            <a:ext cx="1044000" cy="120818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5BC5977-9DB8-E24E-8CF4-AD82A630D3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95" t="49224" r="41907" b="34109"/>
          <a:stretch/>
        </p:blipFill>
        <p:spPr bwMode="auto">
          <a:xfrm rot="10800000" flipH="1" flipV="1">
            <a:off x="3504087" y="3321150"/>
            <a:ext cx="684000" cy="107569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3" name="Picture 22" descr="A screenshot of a cell phone&#10;&#10;Description automatically generated">
            <a:extLst>
              <a:ext uri="{FF2B5EF4-FFF2-40B4-BE49-F238E27FC236}">
                <a16:creationId xmlns:a16="http://schemas.microsoft.com/office/drawing/2014/main" id="{D998B08D-9BB3-AA46-873E-50283716779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610" t="12471" r="58888" b="4277"/>
          <a:stretch/>
        </p:blipFill>
        <p:spPr>
          <a:xfrm>
            <a:off x="2041525" y="5076825"/>
            <a:ext cx="2640487" cy="28098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F85EA80A-1D58-9143-8D8F-52AE97DFF0F3}"/>
              </a:ext>
            </a:extLst>
          </p:cNvPr>
          <p:cNvSpPr/>
          <p:nvPr/>
        </p:nvSpPr>
        <p:spPr>
          <a:xfrm>
            <a:off x="292099" y="8185907"/>
            <a:ext cx="62738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v_FSE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cting RNA  element in the SARS-CoV-2 genom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sequence and RNA structure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v_F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in the position 4,520-4,560 of the SARS-CoV-2 genome. In 3D structure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 phosphodiester backbone is shown in orange, and the nucleotides are shown in the sticks and filled rings with elemental coloring as C green, O red, and N blu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Conservation of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v_F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equence from various coronavirus.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v_F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as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 position= 4,640-4,68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y blue box indicates mismatched nucleotides between the two sequences, wh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box shows gaps between two sequences. Percent identity in the histogram where red indicates a perfect match and magenta shows the low similarity of nucleotide.</a:t>
            </a:r>
          </a:p>
        </p:txBody>
      </p:sp>
    </p:spTree>
    <p:extLst>
      <p:ext uri="{BB962C8B-B14F-4D97-AF65-F5344CB8AC3E}">
        <p14:creationId xmlns:p14="http://schemas.microsoft.com/office/powerpoint/2010/main" val="20611144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5BC80A7C-BF32-6F4E-BAEE-720F810179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3626970"/>
              </p:ext>
            </p:extLst>
          </p:nvPr>
        </p:nvGraphicFramePr>
        <p:xfrm>
          <a:off x="1181277" y="519764"/>
          <a:ext cx="4564884" cy="39855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82442">
                  <a:extLst>
                    <a:ext uri="{9D8B030D-6E8A-4147-A177-3AD203B41FA5}">
                      <a16:colId xmlns:a16="http://schemas.microsoft.com/office/drawing/2014/main" val="3582623480"/>
                    </a:ext>
                  </a:extLst>
                </a:gridCol>
                <a:gridCol w="2282442">
                  <a:extLst>
                    <a:ext uri="{9D8B030D-6E8A-4147-A177-3AD203B41FA5}">
                      <a16:colId xmlns:a16="http://schemas.microsoft.com/office/drawing/2014/main" val="3653733296"/>
                    </a:ext>
                  </a:extLst>
                </a:gridCol>
              </a:tblGrid>
              <a:tr h="31470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earch-Rf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803966"/>
                  </a:ext>
                </a:extLst>
              </a:tr>
              <a:tr h="1347813">
                <a:tc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327281"/>
                  </a:ext>
                </a:extLst>
              </a:tr>
              <a:tr h="720383">
                <a:tc gridSpan="2"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272734"/>
                  </a:ext>
                </a:extLst>
              </a:tr>
              <a:tr h="306621">
                <a:tc gridSpan="2">
                  <a:txBody>
                    <a:bodyPr/>
                    <a:lstStyle/>
                    <a:p>
                      <a:pPr algn="ctr"/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fold 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condary annotations and modelled 3D structure</a:t>
                      </a:r>
                      <a:endParaRPr lang="en-SA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115759"/>
                  </a:ext>
                </a:extLst>
              </a:tr>
              <a:tr h="1296000">
                <a:tc>
                  <a:txBody>
                    <a:bodyPr/>
                    <a:lstStyle/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sequnce: 116</a:t>
                      </a: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match: 2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48173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66B40C8E-DBA1-064A-A3D1-64E35E347D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87" t="34120" r="18861" b="62914"/>
          <a:stretch/>
        </p:blipFill>
        <p:spPr bwMode="auto">
          <a:xfrm>
            <a:off x="3504087" y="1742526"/>
            <a:ext cx="689675" cy="396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CF7F6E-CFAF-6F47-B070-8BC8D3313689}"/>
              </a:ext>
            </a:extLst>
          </p:cNvPr>
          <p:cNvSpPr txBox="1"/>
          <p:nvPr/>
        </p:nvSpPr>
        <p:spPr>
          <a:xfrm>
            <a:off x="1228459" y="898332"/>
            <a:ext cx="201529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Famil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S15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Taxonom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Eukaryota; Bacteria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Ontolog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Not foun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CBBB20-0D38-8942-B3AC-6FD7671A3D09}"/>
              </a:ext>
            </a:extLst>
          </p:cNvPr>
          <p:cNvSpPr txBox="1"/>
          <p:nvPr/>
        </p:nvSpPr>
        <p:spPr>
          <a:xfrm>
            <a:off x="317500" y="29210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323EC85-4FA7-5240-9285-D35C1DD30864}"/>
              </a:ext>
            </a:extLst>
          </p:cNvPr>
          <p:cNvSpPr/>
          <p:nvPr/>
        </p:nvSpPr>
        <p:spPr>
          <a:xfrm>
            <a:off x="327118" y="479911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B70EECD-33D2-F943-8E88-D4E65603943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56" t="41222" r="44019" b="48028"/>
          <a:stretch/>
        </p:blipFill>
        <p:spPr bwMode="auto">
          <a:xfrm>
            <a:off x="2288520" y="2259426"/>
            <a:ext cx="2117868" cy="50619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0503BEE-6C71-7B44-ACA7-8FBDD988712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567" t="20029" r="20781" b="65977"/>
          <a:stretch/>
        </p:blipFill>
        <p:spPr bwMode="auto">
          <a:xfrm>
            <a:off x="4469857" y="879373"/>
            <a:ext cx="1116000" cy="12773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3B6E84D-2B29-3142-8A02-5890ADF0680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71" t="59545" r="32684" b="28614"/>
          <a:stretch/>
        </p:blipFill>
        <p:spPr bwMode="auto">
          <a:xfrm>
            <a:off x="1299251" y="3254599"/>
            <a:ext cx="2088000" cy="40549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6" name="Picture 25" descr="A close up of a logo&#10;&#10;Description automatically generated">
            <a:extLst>
              <a:ext uri="{FF2B5EF4-FFF2-40B4-BE49-F238E27FC236}">
                <a16:creationId xmlns:a16="http://schemas.microsoft.com/office/drawing/2014/main" id="{28777D7C-54BC-FD41-8460-9DDF07E131D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268" r="11631"/>
          <a:stretch/>
        </p:blipFill>
        <p:spPr>
          <a:xfrm flipV="1">
            <a:off x="4713620" y="3226241"/>
            <a:ext cx="1008000" cy="113303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008CF58-4C9C-FF43-83D8-165D87B48C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77" t="68150" r="18228" b="15606"/>
          <a:stretch/>
        </p:blipFill>
        <p:spPr bwMode="auto">
          <a:xfrm>
            <a:off x="3525620" y="3276023"/>
            <a:ext cx="1188000" cy="111686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8" name="Picture 27" descr="A close up of a device&#10;&#10;Description automatically generated">
            <a:extLst>
              <a:ext uri="{FF2B5EF4-FFF2-40B4-BE49-F238E27FC236}">
                <a16:creationId xmlns:a16="http://schemas.microsoft.com/office/drawing/2014/main" id="{0F296A16-ACA1-5D49-85E9-4BFE5C4C9A6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187" t="13126" r="65859" b="3897"/>
          <a:stretch/>
        </p:blipFill>
        <p:spPr>
          <a:xfrm>
            <a:off x="2348916" y="4994262"/>
            <a:ext cx="2122825" cy="27865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9A043C34-6B0F-AA48-BCD2-5C81ACFC6C1D}"/>
              </a:ext>
            </a:extLst>
          </p:cNvPr>
          <p:cNvSpPr/>
          <p:nvPr/>
        </p:nvSpPr>
        <p:spPr>
          <a:xfrm>
            <a:off x="265733" y="8256636"/>
            <a:ext cx="6273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15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cting RNA  element in the SARS-CoV-2 genom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sequence and RNA structure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in the position 12,220-12,250 of the SARS-CoV-2 genome. In 3D structure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 phosphodiester backbone is shown in orange, and the nucleotides are shown in the sticks and filled rings with elemental coloring as C green, O red, and N blu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Conservation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equence from various coronavirus. Th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as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 position= 12,685-12,71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y blue box indicates mismatched nucleotides between the two sequences, wh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box shows gaps between two sequences. Percent identity in the histogram where red indicates a perfect match and magenta shows the low similarity of nucleotide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7145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5BC80A7C-BF32-6F4E-BAEE-720F810179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3668973"/>
              </p:ext>
            </p:extLst>
          </p:nvPr>
        </p:nvGraphicFramePr>
        <p:xfrm>
          <a:off x="1181277" y="519764"/>
          <a:ext cx="4564884" cy="39855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82442">
                  <a:extLst>
                    <a:ext uri="{9D8B030D-6E8A-4147-A177-3AD203B41FA5}">
                      <a16:colId xmlns:a16="http://schemas.microsoft.com/office/drawing/2014/main" val="3582623480"/>
                    </a:ext>
                  </a:extLst>
                </a:gridCol>
                <a:gridCol w="2282442">
                  <a:extLst>
                    <a:ext uri="{9D8B030D-6E8A-4147-A177-3AD203B41FA5}">
                      <a16:colId xmlns:a16="http://schemas.microsoft.com/office/drawing/2014/main" val="3653733296"/>
                    </a:ext>
                  </a:extLst>
                </a:gridCol>
              </a:tblGrid>
              <a:tr h="31470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earch-Rf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803966"/>
                  </a:ext>
                </a:extLst>
              </a:tr>
              <a:tr h="1347813">
                <a:tc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327281"/>
                  </a:ext>
                </a:extLst>
              </a:tr>
              <a:tr h="720383">
                <a:tc gridSpan="2"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272734"/>
                  </a:ext>
                </a:extLst>
              </a:tr>
              <a:tr h="306621">
                <a:tc gridSpan="2">
                  <a:txBody>
                    <a:bodyPr/>
                    <a:lstStyle/>
                    <a:p>
                      <a:pPr algn="ctr"/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fold 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condary annotations and modelled 3D structure</a:t>
                      </a:r>
                      <a:endParaRPr lang="en-SA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115759"/>
                  </a:ext>
                </a:extLst>
              </a:tr>
              <a:tr h="1296000">
                <a:tc>
                  <a:txBody>
                    <a:bodyPr/>
                    <a:lstStyle/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sequnce: 99</a:t>
                      </a: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match: 8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48173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66B40C8E-DBA1-064A-A3D1-64E35E347D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87" t="34120" r="18861" b="62914"/>
          <a:stretch/>
        </p:blipFill>
        <p:spPr bwMode="auto">
          <a:xfrm>
            <a:off x="3488219" y="1759893"/>
            <a:ext cx="689675" cy="396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CF7F6E-CFAF-6F47-B070-8BC8D3313689}"/>
              </a:ext>
            </a:extLst>
          </p:cNvPr>
          <p:cNvSpPr txBox="1"/>
          <p:nvPr/>
        </p:nvSpPr>
        <p:spPr>
          <a:xfrm>
            <a:off x="1228459" y="898332"/>
            <a:ext cx="191590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Famil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PYLIS_2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Taxonom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Bacteria; Archaea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Ontolog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GO:0030631 </a:t>
            </a:r>
          </a:p>
          <a:p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(pyrrolysine incorporatio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CBBB20-0D38-8942-B3AC-6FD7671A3D09}"/>
              </a:ext>
            </a:extLst>
          </p:cNvPr>
          <p:cNvSpPr txBox="1"/>
          <p:nvPr/>
        </p:nvSpPr>
        <p:spPr>
          <a:xfrm>
            <a:off x="317500" y="29210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323EC85-4FA7-5240-9285-D35C1DD30864}"/>
              </a:ext>
            </a:extLst>
          </p:cNvPr>
          <p:cNvSpPr/>
          <p:nvPr/>
        </p:nvSpPr>
        <p:spPr>
          <a:xfrm>
            <a:off x="327118" y="479911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A6F1E7B-5C48-5D46-94FA-1A58B0EFF87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525" t="21506" r="18459" b="69828"/>
          <a:stretch/>
        </p:blipFill>
        <p:spPr bwMode="auto">
          <a:xfrm>
            <a:off x="4162964" y="1033768"/>
            <a:ext cx="1511387" cy="9241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E9CD8C0-D90D-EC41-BA2B-BFD4464B01A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87" t="55875" r="31532" b="30601"/>
          <a:stretch/>
        </p:blipFill>
        <p:spPr bwMode="auto">
          <a:xfrm>
            <a:off x="1314633" y="3263569"/>
            <a:ext cx="2088000" cy="47086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E7362ADA-3810-054A-9A8F-B7B8801F764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43" t="37512" r="15315" b="51158"/>
          <a:stretch/>
        </p:blipFill>
        <p:spPr bwMode="auto">
          <a:xfrm>
            <a:off x="1334038" y="2231344"/>
            <a:ext cx="4308363" cy="58521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08C46E4-885C-4F4F-8724-A48ECD81DA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8205384">
            <a:off x="3661668" y="3412003"/>
            <a:ext cx="900000" cy="900000"/>
          </a:xfrm>
          <a:prstGeom prst="rect">
            <a:avLst/>
          </a:prstGeom>
        </p:spPr>
      </p:pic>
      <p:pic>
        <p:nvPicPr>
          <p:cNvPr id="22" name="Picture 21" descr="A close up of a map&#10;&#10;Description automatically generated">
            <a:extLst>
              <a:ext uri="{FF2B5EF4-FFF2-40B4-BE49-F238E27FC236}">
                <a16:creationId xmlns:a16="http://schemas.microsoft.com/office/drawing/2014/main" id="{8CAC1961-A541-A249-9CFF-3A3EFDD48F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700" r="4409"/>
          <a:stretch/>
        </p:blipFill>
        <p:spPr>
          <a:xfrm>
            <a:off x="4594351" y="3262266"/>
            <a:ext cx="1080000" cy="1142608"/>
          </a:xfrm>
          <a:prstGeom prst="rect">
            <a:avLst/>
          </a:prstGeom>
        </p:spPr>
      </p:pic>
      <p:pic>
        <p:nvPicPr>
          <p:cNvPr id="24" name="Picture 23" descr="A screenshot of a cell phone&#10;&#10;Description automatically generated">
            <a:extLst>
              <a:ext uri="{FF2B5EF4-FFF2-40B4-BE49-F238E27FC236}">
                <a16:creationId xmlns:a16="http://schemas.microsoft.com/office/drawing/2014/main" id="{1E000B82-6C9F-6F42-9870-9523DA51564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729" t="12397" r="27771" b="3786"/>
          <a:stretch/>
        </p:blipFill>
        <p:spPr>
          <a:xfrm>
            <a:off x="1132317" y="5400719"/>
            <a:ext cx="4768293" cy="28203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Rectangle 29">
            <a:extLst>
              <a:ext uri="{FF2B5EF4-FFF2-40B4-BE49-F238E27FC236}">
                <a16:creationId xmlns:a16="http://schemas.microsoft.com/office/drawing/2014/main" id="{C5073B1A-BCF5-2646-8EF5-4462BC534A6D}"/>
              </a:ext>
            </a:extLst>
          </p:cNvPr>
          <p:cNvSpPr/>
          <p:nvPr/>
        </p:nvSpPr>
        <p:spPr>
          <a:xfrm>
            <a:off x="388164" y="8283373"/>
            <a:ext cx="6273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PYLIS_2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i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acting RNA  element in the SARS-CoV-2 genom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sequence and RNA structure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YLIS_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in the position 24,221-24,306 of the SARS-CoV-2 genome. In 3D structure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 phosphodiester backbone is shown in orange, and the nucleotides are shown in the sticks and filled rings with elemental coloring as C green, O red, and N blu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Conservation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YLIS_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equence from various coronavirus. Th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YLIS_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as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 position= 25,007-25,09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y blue box indicates mismatched nucleotides between the two sequences, wh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box shows gaps between two sequences. Percent identity in the histogram where red indicates a perfect match and magenta shows the low similarity of nucleotide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53689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5BC80A7C-BF32-6F4E-BAEE-720F810179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3148581"/>
              </p:ext>
            </p:extLst>
          </p:nvPr>
        </p:nvGraphicFramePr>
        <p:xfrm>
          <a:off x="1181277" y="519764"/>
          <a:ext cx="4564884" cy="39855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82442">
                  <a:extLst>
                    <a:ext uri="{9D8B030D-6E8A-4147-A177-3AD203B41FA5}">
                      <a16:colId xmlns:a16="http://schemas.microsoft.com/office/drawing/2014/main" val="3582623480"/>
                    </a:ext>
                  </a:extLst>
                </a:gridCol>
                <a:gridCol w="2282442">
                  <a:extLst>
                    <a:ext uri="{9D8B030D-6E8A-4147-A177-3AD203B41FA5}">
                      <a16:colId xmlns:a16="http://schemas.microsoft.com/office/drawing/2014/main" val="3653733296"/>
                    </a:ext>
                  </a:extLst>
                </a:gridCol>
              </a:tblGrid>
              <a:tr h="31470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earch-Rf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803966"/>
                  </a:ext>
                </a:extLst>
              </a:tr>
              <a:tr h="1347813">
                <a:tc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327281"/>
                  </a:ext>
                </a:extLst>
              </a:tr>
              <a:tr h="720383">
                <a:tc gridSpan="2"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272734"/>
                  </a:ext>
                </a:extLst>
              </a:tr>
              <a:tr h="306621">
                <a:tc gridSpan="2">
                  <a:txBody>
                    <a:bodyPr/>
                    <a:lstStyle/>
                    <a:p>
                      <a:pPr algn="ctr"/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fold 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condary annotations and modelled 3D structure</a:t>
                      </a:r>
                      <a:endParaRPr lang="en-SA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115759"/>
                  </a:ext>
                </a:extLst>
              </a:tr>
              <a:tr h="1296000">
                <a:tc>
                  <a:txBody>
                    <a:bodyPr/>
                    <a:lstStyle/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sequnce: 57</a:t>
                      </a: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match: 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48173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66B40C8E-DBA1-064A-A3D1-64E35E347D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87" t="34120" r="18861" b="62914"/>
          <a:stretch/>
        </p:blipFill>
        <p:spPr bwMode="auto">
          <a:xfrm>
            <a:off x="3488219" y="1759893"/>
            <a:ext cx="689675" cy="396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CF7F6E-CFAF-6F47-B070-8BC8D3313689}"/>
              </a:ext>
            </a:extLst>
          </p:cNvPr>
          <p:cNvSpPr txBox="1"/>
          <p:nvPr/>
        </p:nvSpPr>
        <p:spPr>
          <a:xfrm>
            <a:off x="1228459" y="898332"/>
            <a:ext cx="201529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Famil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ClpQY_promoter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Taxonom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Eukaryota; Bacteria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Ontolog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GO:0048255 </a:t>
            </a:r>
          </a:p>
          <a:p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(mRNA stabilizatio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CBBB20-0D38-8942-B3AC-6FD7671A3D09}"/>
              </a:ext>
            </a:extLst>
          </p:cNvPr>
          <p:cNvSpPr txBox="1"/>
          <p:nvPr/>
        </p:nvSpPr>
        <p:spPr>
          <a:xfrm>
            <a:off x="317500" y="29210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323EC85-4FA7-5240-9285-D35C1DD30864}"/>
              </a:ext>
            </a:extLst>
          </p:cNvPr>
          <p:cNvSpPr/>
          <p:nvPr/>
        </p:nvSpPr>
        <p:spPr>
          <a:xfrm>
            <a:off x="327118" y="479911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852898B-E947-CD41-A65B-E5C0AFA595C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76" t="39698" r="28232" b="47494"/>
          <a:stretch/>
        </p:blipFill>
        <p:spPr bwMode="auto">
          <a:xfrm>
            <a:off x="1721112" y="2199827"/>
            <a:ext cx="3384000" cy="69135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D9B108B-AB76-824D-8DC2-2EBEA3451C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89" t="20431" r="21574" b="66081"/>
          <a:stretch/>
        </p:blipFill>
        <p:spPr bwMode="auto">
          <a:xfrm>
            <a:off x="4207253" y="898332"/>
            <a:ext cx="1512000" cy="122756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E6615A4-62C4-B74C-9334-87B49460FC2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20" t="59036" r="36477" b="30918"/>
          <a:stretch/>
        </p:blipFill>
        <p:spPr bwMode="auto">
          <a:xfrm>
            <a:off x="1240816" y="3309534"/>
            <a:ext cx="2124000" cy="41413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5" name="Picture 24" descr="A close up of a flower&#10;&#10;Description automatically generated">
            <a:extLst>
              <a:ext uri="{FF2B5EF4-FFF2-40B4-BE49-F238E27FC236}">
                <a16:creationId xmlns:a16="http://schemas.microsoft.com/office/drawing/2014/main" id="{23BDC1C4-525B-1D42-8A3B-354932306D2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875" r="32712"/>
          <a:stretch/>
        </p:blipFill>
        <p:spPr>
          <a:xfrm flipV="1">
            <a:off x="4647743" y="3289033"/>
            <a:ext cx="540000" cy="111992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ECAB603-E0F5-A14C-9CC1-0133B3B37F8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71" t="57856" r="24018" b="22819"/>
          <a:stretch/>
        </p:blipFill>
        <p:spPr bwMode="auto">
          <a:xfrm>
            <a:off x="3605098" y="3309534"/>
            <a:ext cx="612000" cy="111240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7" name="Picture 26" descr="A screenshot of a cell phone&#10;&#10;Description automatically generated">
            <a:extLst>
              <a:ext uri="{FF2B5EF4-FFF2-40B4-BE49-F238E27FC236}">
                <a16:creationId xmlns:a16="http://schemas.microsoft.com/office/drawing/2014/main" id="{EAFFE7B6-9648-DE42-9BCC-57BC92995B6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641" t="12180" r="57623" b="3675"/>
          <a:stretch/>
        </p:blipFill>
        <p:spPr>
          <a:xfrm>
            <a:off x="2066457" y="5202789"/>
            <a:ext cx="2725086" cy="27969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07E07920-5EBA-2D4A-BCF6-4794192C96ED}"/>
              </a:ext>
            </a:extLst>
          </p:cNvPr>
          <p:cNvSpPr/>
          <p:nvPr/>
        </p:nvSpPr>
        <p:spPr>
          <a:xfrm>
            <a:off x="292100" y="8121929"/>
            <a:ext cx="62738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QY_promot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cting RNA  element in the SARS-CoV-2 genom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sequence and RNA structure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QY_promo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in the position 1,853-1,892 of the SARS-CoV-2 genome. In 3D structure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 phosphodiester backbone is shown in orange, and the nucleotides are shown in the sticks and filled rings with elemental coloring as C green, O red, and N blu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Conservation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QY_promo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equence from various coronavirus.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QY_promo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as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 position= 1,918-1,95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y blue box indicates mismatched nucleotides between the two sequences, wh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box shows gaps between two sequences. Percent identity in the histogram where red indicates a perfect match and magenta shows the low similarity of nucleotide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13544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A picture containing mirror&#10;&#10;Description automatically generated">
            <a:extLst>
              <a:ext uri="{FF2B5EF4-FFF2-40B4-BE49-F238E27FC236}">
                <a16:creationId xmlns:a16="http://schemas.microsoft.com/office/drawing/2014/main" id="{073AD255-1495-EA43-A476-B7F282BDB6B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3424" b="25769"/>
          <a:stretch/>
        </p:blipFill>
        <p:spPr>
          <a:xfrm rot="18836658">
            <a:off x="3328401" y="3537403"/>
            <a:ext cx="1188000" cy="603575"/>
          </a:xfrm>
          <a:prstGeom prst="rect">
            <a:avLst/>
          </a:prstGeom>
        </p:spPr>
      </p:pic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5BC80A7C-BF32-6F4E-BAEE-720F810179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7659008"/>
              </p:ext>
            </p:extLst>
          </p:nvPr>
        </p:nvGraphicFramePr>
        <p:xfrm>
          <a:off x="1181277" y="519764"/>
          <a:ext cx="4564884" cy="39855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82442">
                  <a:extLst>
                    <a:ext uri="{9D8B030D-6E8A-4147-A177-3AD203B41FA5}">
                      <a16:colId xmlns:a16="http://schemas.microsoft.com/office/drawing/2014/main" val="3582623480"/>
                    </a:ext>
                  </a:extLst>
                </a:gridCol>
                <a:gridCol w="2282442">
                  <a:extLst>
                    <a:ext uri="{9D8B030D-6E8A-4147-A177-3AD203B41FA5}">
                      <a16:colId xmlns:a16="http://schemas.microsoft.com/office/drawing/2014/main" val="3653733296"/>
                    </a:ext>
                  </a:extLst>
                </a:gridCol>
              </a:tblGrid>
              <a:tr h="31470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earch-Rf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803966"/>
                  </a:ext>
                </a:extLst>
              </a:tr>
              <a:tr h="1347813">
                <a:tc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327281"/>
                  </a:ext>
                </a:extLst>
              </a:tr>
              <a:tr h="720383">
                <a:tc gridSpan="2"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272734"/>
                  </a:ext>
                </a:extLst>
              </a:tr>
              <a:tr h="306621">
                <a:tc gridSpan="2">
                  <a:txBody>
                    <a:bodyPr/>
                    <a:lstStyle/>
                    <a:p>
                      <a:pPr algn="ctr"/>
                      <a:r>
                        <a:rPr lang="en-SA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fold 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condary annotations and modelled 3D structure</a:t>
                      </a:r>
                      <a:endParaRPr lang="en-SA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115759"/>
                  </a:ext>
                </a:extLst>
              </a:tr>
              <a:tr h="1296000">
                <a:tc>
                  <a:txBody>
                    <a:bodyPr/>
                    <a:lstStyle/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SA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sequnce: 53</a:t>
                      </a:r>
                    </a:p>
                    <a:p>
                      <a:r>
                        <a:rPr lang="en-SA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match: 5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  <a:p>
                      <a:endParaRPr lang="en-SA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48173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66B40C8E-DBA1-064A-A3D1-64E35E347D8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87" t="34120" r="18861" b="62914"/>
          <a:stretch/>
        </p:blipFill>
        <p:spPr bwMode="auto">
          <a:xfrm>
            <a:off x="3488219" y="1759893"/>
            <a:ext cx="689675" cy="396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CF7F6E-CFAF-6F47-B070-8BC8D3313689}"/>
              </a:ext>
            </a:extLst>
          </p:cNvPr>
          <p:cNvSpPr txBox="1"/>
          <p:nvPr/>
        </p:nvSpPr>
        <p:spPr>
          <a:xfrm>
            <a:off x="1228459" y="898332"/>
            <a:ext cx="2137124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Famil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Histone3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Taxonom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Eukaryota; Bacteria;</a:t>
            </a:r>
          </a:p>
          <a:p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Viruses; Archaea </a:t>
            </a:r>
          </a:p>
          <a:p>
            <a:r>
              <a:rPr lang="en-SA" sz="1000" b="1" dirty="0">
                <a:latin typeface="Arial" panose="020B0604020202020204" pitchFamily="34" charset="0"/>
                <a:cs typeface="Arial" panose="020B0604020202020204" pitchFamily="34" charset="0"/>
              </a:rPr>
              <a:t>Ontology: </a:t>
            </a:r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GO:0006398 </a:t>
            </a:r>
          </a:p>
          <a:p>
            <a:r>
              <a:rPr lang="en-SA" sz="1000" dirty="0">
                <a:latin typeface="Arial" panose="020B0604020202020204" pitchFamily="34" charset="0"/>
                <a:cs typeface="Arial" panose="020B0604020202020204" pitchFamily="34" charset="0"/>
              </a:rPr>
              <a:t>(histone mRNA 3’-end processing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CBBB20-0D38-8942-B3AC-6FD7671A3D09}"/>
              </a:ext>
            </a:extLst>
          </p:cNvPr>
          <p:cNvSpPr txBox="1"/>
          <p:nvPr/>
        </p:nvSpPr>
        <p:spPr>
          <a:xfrm>
            <a:off x="317500" y="29210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323EC85-4FA7-5240-9285-D35C1DD30864}"/>
              </a:ext>
            </a:extLst>
          </p:cNvPr>
          <p:cNvSpPr/>
          <p:nvPr/>
        </p:nvSpPr>
        <p:spPr>
          <a:xfrm>
            <a:off x="327118" y="479911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603BC9B-7414-CA47-BB46-6A6CD07F209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80" t="52121" r="28248" b="35010"/>
          <a:stretch/>
        </p:blipFill>
        <p:spPr bwMode="auto">
          <a:xfrm>
            <a:off x="2017027" y="2246593"/>
            <a:ext cx="2776943" cy="57573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236881A-F849-4443-8FDF-2B5B936764E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04" t="27238" r="4808" b="58411"/>
          <a:stretch/>
        </p:blipFill>
        <p:spPr bwMode="auto">
          <a:xfrm>
            <a:off x="4164723" y="876521"/>
            <a:ext cx="1512000" cy="127937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B991295-A84C-BD4F-91EC-8E6A60F4B73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6" t="71346" r="26613" b="18109"/>
          <a:stretch/>
        </p:blipFill>
        <p:spPr bwMode="auto">
          <a:xfrm>
            <a:off x="1245499" y="3279836"/>
            <a:ext cx="2160000" cy="3938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2" name="Picture 21" descr="A picture containing flower, fruit, table&#10;&#10;Description automatically generated">
            <a:extLst>
              <a:ext uri="{FF2B5EF4-FFF2-40B4-BE49-F238E27FC236}">
                <a16:creationId xmlns:a16="http://schemas.microsoft.com/office/drawing/2014/main" id="{55B76E52-D738-2D42-A7D4-F8F9D798A66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862" t="13067" r="30048"/>
          <a:stretch/>
        </p:blipFill>
        <p:spPr>
          <a:xfrm>
            <a:off x="4450590" y="3254657"/>
            <a:ext cx="1260000" cy="116906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289EB86-62C0-E448-982F-F4F0DA10A9C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525" t="12466" r="44271" b="4285"/>
          <a:stretch/>
        </p:blipFill>
        <p:spPr>
          <a:xfrm>
            <a:off x="1740783" y="5256578"/>
            <a:ext cx="3654426" cy="28116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BB28E4E8-E10E-9B4E-B6D1-220371401F1B}"/>
              </a:ext>
            </a:extLst>
          </p:cNvPr>
          <p:cNvSpPr/>
          <p:nvPr/>
        </p:nvSpPr>
        <p:spPr>
          <a:xfrm>
            <a:off x="431096" y="8336340"/>
            <a:ext cx="6273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one3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acting RNA  element in the SARS-CoV-2 genom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sequence and RNA structure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one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in the position 6,896-6,949 of the SARS-CoV-2 genome. In 3D structure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 phosphodiester backbone is shown in orange, and the nucleotides are shown in the sticks and filled rings with elemental coloring as C green, O red, and N blu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Conservation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one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equence from various coronavirus. Th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one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located as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 position</a:t>
            </a:r>
            <a:r>
              <a:rPr lang="en-SA" sz="1200">
                <a:latin typeface="Times New Roman" panose="02020603050405020304" pitchFamily="18" charset="0"/>
                <a:cs typeface="Times New Roman" panose="02020603050405020304" pitchFamily="18" charset="0"/>
              </a:rPr>
              <a:t>= 7,206-7,264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y blue box indicates mismatched nucleotides between the two sequences, wh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S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box shows gaps between two sequences. Percent identity in the histogram where red indicates a perfect match and magenta shows the low similarity of nucleotide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419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9</TotalTime>
  <Words>921</Words>
  <Application>Microsoft Macintosh PowerPoint</Application>
  <PresentationFormat>A4 Paper (210x297 mm)</PresentationFormat>
  <Paragraphs>11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roz Ahmed</dc:creator>
  <cp:lastModifiedBy>Firoz S. Ahmed</cp:lastModifiedBy>
  <cp:revision>265</cp:revision>
  <dcterms:created xsi:type="dcterms:W3CDTF">2020-05-12T22:31:43Z</dcterms:created>
  <dcterms:modified xsi:type="dcterms:W3CDTF">2020-10-13T16:38:42Z</dcterms:modified>
</cp:coreProperties>
</file>